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92003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0" d="100"/>
          <a:sy n="400" d="100"/>
        </p:scale>
        <p:origin x="-6322" y="-179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472842"/>
            <a:ext cx="6732032" cy="3133172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4726842"/>
            <a:ext cx="5940029" cy="2172804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526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64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479142"/>
            <a:ext cx="1707758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479142"/>
            <a:ext cx="5024274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2259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5144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2243638"/>
            <a:ext cx="6831033" cy="3743557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6022610"/>
            <a:ext cx="6831033" cy="1968648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>
                    <a:tint val="82000"/>
                  </a:schemeClr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82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82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7681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395710"/>
            <a:ext cx="3366016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395710"/>
            <a:ext cx="3366016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4823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79144"/>
            <a:ext cx="6831033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206137"/>
            <a:ext cx="3350547" cy="108119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3287331"/>
            <a:ext cx="335054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206137"/>
            <a:ext cx="3367048" cy="108119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3287331"/>
            <a:ext cx="336704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645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5139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1971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99969"/>
            <a:ext cx="2554418" cy="209989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295769"/>
            <a:ext cx="4009519" cy="6395505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699862"/>
            <a:ext cx="2554418" cy="500182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972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99969"/>
            <a:ext cx="2554418" cy="209989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295769"/>
            <a:ext cx="4009519" cy="6395505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699862"/>
            <a:ext cx="2554418" cy="500182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122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479144"/>
            <a:ext cx="6831033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395710"/>
            <a:ext cx="6831033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8341240"/>
            <a:ext cx="178200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8341240"/>
            <a:ext cx="2673013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8341240"/>
            <a:ext cx="178200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1591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id="{FEB519A0-F385-2A8C-E565-9C6D716E10A0}"/>
              </a:ext>
            </a:extLst>
          </p:cNvPr>
          <p:cNvSpPr txBox="1"/>
          <p:nvPr/>
        </p:nvSpPr>
        <p:spPr>
          <a:xfrm>
            <a:off x="630027" y="270040"/>
            <a:ext cx="4638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400" b="1" dirty="0">
                <a:solidFill>
                  <a:prstClr val="black"/>
                </a:solidFill>
                <a:latin typeface="等线" panose="020F0502020204030204"/>
              </a:rPr>
              <a:t>A</a:t>
            </a:r>
            <a:endParaRPr lang="zh-CN" altLang="en-US" sz="2400" b="1" dirty="0">
              <a:solidFill>
                <a:prstClr val="black"/>
              </a:solidFill>
              <a:latin typeface="等线" panose="020F0502020204030204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7CFBCC8-D421-1D78-5847-1F3F9E922B1F}"/>
              </a:ext>
            </a:extLst>
          </p:cNvPr>
          <p:cNvSpPr txBox="1"/>
          <p:nvPr/>
        </p:nvSpPr>
        <p:spPr>
          <a:xfrm>
            <a:off x="630027" y="5605357"/>
            <a:ext cx="4638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400" b="1" dirty="0">
                <a:solidFill>
                  <a:prstClr val="black"/>
                </a:solidFill>
                <a:latin typeface="等线" panose="020F0502020204030204"/>
              </a:rPr>
              <a:t>B</a:t>
            </a:r>
            <a:endParaRPr lang="zh-CN" altLang="en-US" sz="2400" b="1" dirty="0">
              <a:solidFill>
                <a:prstClr val="black"/>
              </a:solidFill>
              <a:latin typeface="等线" panose="020F0502020204030204"/>
            </a:endParaRPr>
          </a:p>
        </p:txBody>
      </p:sp>
      <p:pic>
        <p:nvPicPr>
          <p:cNvPr id="18" name="图片 17" descr="图表, 条形图&#10;&#10;描述已自动生成">
            <a:extLst>
              <a:ext uri="{FF2B5EF4-FFF2-40B4-BE49-F238E27FC236}">
                <a16:creationId xmlns:a16="http://schemas.microsoft.com/office/drawing/2014/main" id="{810E49CE-5EC4-AEF0-4860-C5BF3DAD46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0008" y="787834"/>
            <a:ext cx="1562115" cy="2236471"/>
          </a:xfrm>
          <a:prstGeom prst="rect">
            <a:avLst/>
          </a:prstGeom>
        </p:spPr>
      </p:pic>
      <p:pic>
        <p:nvPicPr>
          <p:cNvPr id="19" name="图片 18" descr="图表, 条形图&#10;&#10;描述已自动生成">
            <a:extLst>
              <a:ext uri="{FF2B5EF4-FFF2-40B4-BE49-F238E27FC236}">
                <a16:creationId xmlns:a16="http://schemas.microsoft.com/office/drawing/2014/main" id="{6B2E051F-1581-E6B1-D97E-BF8033E65E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5773" y="3155833"/>
            <a:ext cx="1562115" cy="2236471"/>
          </a:xfrm>
          <a:prstGeom prst="rect">
            <a:avLst/>
          </a:prstGeom>
        </p:spPr>
      </p:pic>
      <p:pic>
        <p:nvPicPr>
          <p:cNvPr id="20" name="图片 19" descr="图表, 条形图&#10;&#10;描述已自动生成">
            <a:extLst>
              <a:ext uri="{FF2B5EF4-FFF2-40B4-BE49-F238E27FC236}">
                <a16:creationId xmlns:a16="http://schemas.microsoft.com/office/drawing/2014/main" id="{47EDE5FC-986E-591B-D3CE-29141F2E50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3912" y="3155833"/>
            <a:ext cx="1563335" cy="2236471"/>
          </a:xfrm>
          <a:prstGeom prst="rect">
            <a:avLst/>
          </a:prstGeom>
        </p:spPr>
      </p:pic>
      <p:pic>
        <p:nvPicPr>
          <p:cNvPr id="21" name="图片 20" descr="图表, 条形图&#10;&#10;描述已自动生成">
            <a:extLst>
              <a:ext uri="{FF2B5EF4-FFF2-40B4-BE49-F238E27FC236}">
                <a16:creationId xmlns:a16="http://schemas.microsoft.com/office/drawing/2014/main" id="{4BC5C340-5341-0D1C-47C2-FC85B04AA17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634" y="3155833"/>
            <a:ext cx="1562115" cy="2236471"/>
          </a:xfrm>
          <a:prstGeom prst="rect">
            <a:avLst/>
          </a:prstGeom>
        </p:spPr>
      </p:pic>
      <p:pic>
        <p:nvPicPr>
          <p:cNvPr id="22" name="图片 21" descr="图表, 条形图&#10;&#10;描述已自动生成">
            <a:extLst>
              <a:ext uri="{FF2B5EF4-FFF2-40B4-BE49-F238E27FC236}">
                <a16:creationId xmlns:a16="http://schemas.microsoft.com/office/drawing/2014/main" id="{B04901F6-8749-FD43-5767-D59990B01C9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5773" y="787834"/>
            <a:ext cx="1562115" cy="2236471"/>
          </a:xfrm>
          <a:prstGeom prst="rect">
            <a:avLst/>
          </a:prstGeom>
        </p:spPr>
      </p:pic>
      <p:pic>
        <p:nvPicPr>
          <p:cNvPr id="23" name="图片 22" descr="图表, 条形图&#10;&#10;描述已自动生成">
            <a:extLst>
              <a:ext uri="{FF2B5EF4-FFF2-40B4-BE49-F238E27FC236}">
                <a16:creationId xmlns:a16="http://schemas.microsoft.com/office/drawing/2014/main" id="{ACC55725-C354-6DBA-14DB-FB989A0E3DB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634" y="787834"/>
            <a:ext cx="1562115" cy="2236471"/>
          </a:xfrm>
          <a:prstGeom prst="rect">
            <a:avLst/>
          </a:prstGeom>
        </p:spPr>
      </p:pic>
      <p:pic>
        <p:nvPicPr>
          <p:cNvPr id="24" name="图片 23" descr="图表, 条形图&#10;&#10;描述已自动生成">
            <a:extLst>
              <a:ext uri="{FF2B5EF4-FFF2-40B4-BE49-F238E27FC236}">
                <a16:creationId xmlns:a16="http://schemas.microsoft.com/office/drawing/2014/main" id="{120AC1D9-C925-2C91-D78D-6481BEFF80E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3699" y="6213773"/>
            <a:ext cx="1466311" cy="2100949"/>
          </a:xfrm>
          <a:prstGeom prst="rect">
            <a:avLst/>
          </a:prstGeom>
        </p:spPr>
      </p:pic>
      <p:pic>
        <p:nvPicPr>
          <p:cNvPr id="25" name="图片 24" descr="图表, 条形图&#10;&#10;描述已自动生成">
            <a:extLst>
              <a:ext uri="{FF2B5EF4-FFF2-40B4-BE49-F238E27FC236}">
                <a16:creationId xmlns:a16="http://schemas.microsoft.com/office/drawing/2014/main" id="{EA94F53E-E09F-D65E-260D-413BCD207CB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7076" y="6213773"/>
            <a:ext cx="1467457" cy="2100949"/>
          </a:xfrm>
          <a:prstGeom prst="rect">
            <a:avLst/>
          </a:prstGeom>
        </p:spPr>
      </p:pic>
      <p:pic>
        <p:nvPicPr>
          <p:cNvPr id="26" name="图片 25" descr="图表, 条形图&#10;&#10;描述已自动生成">
            <a:extLst>
              <a:ext uri="{FF2B5EF4-FFF2-40B4-BE49-F238E27FC236}">
                <a16:creationId xmlns:a16="http://schemas.microsoft.com/office/drawing/2014/main" id="{1E2BF2F9-5A98-64E9-123A-8557960C0CF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1600" y="6213773"/>
            <a:ext cx="1466311" cy="2100949"/>
          </a:xfrm>
          <a:prstGeom prst="rect">
            <a:avLst/>
          </a:prstGeom>
        </p:spPr>
      </p:pic>
      <p:pic>
        <p:nvPicPr>
          <p:cNvPr id="27" name="图片 26" descr="图表, 条形图&#10;&#10;描述已自动生成">
            <a:extLst>
              <a:ext uri="{FF2B5EF4-FFF2-40B4-BE49-F238E27FC236}">
                <a16:creationId xmlns:a16="http://schemas.microsoft.com/office/drawing/2014/main" id="{D8CDC24B-3685-409D-DA0F-37EFE31319E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124" y="6213773"/>
            <a:ext cx="1466311" cy="2100949"/>
          </a:xfrm>
          <a:prstGeom prst="rect">
            <a:avLst/>
          </a:prstGeom>
        </p:spPr>
      </p:pic>
      <p:sp>
        <p:nvSpPr>
          <p:cNvPr id="46" name="矩形 45">
            <a:extLst>
              <a:ext uri="{FF2B5EF4-FFF2-40B4-BE49-F238E27FC236}">
                <a16:creationId xmlns:a16="http://schemas.microsoft.com/office/drawing/2014/main" id="{6F060187-C94D-D8C7-917B-5F3B63ED0DC7}"/>
              </a:ext>
            </a:extLst>
          </p:cNvPr>
          <p:cNvSpPr/>
          <p:nvPr/>
        </p:nvSpPr>
        <p:spPr>
          <a:xfrm rot="16200000">
            <a:off x="1347359" y="2393925"/>
            <a:ext cx="695658" cy="6659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endParaRPr lang="zh-CN" altLang="en-US" sz="160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DFE5F22-CAB3-9F28-22D0-4747F07F7EC7}"/>
              </a:ext>
            </a:extLst>
          </p:cNvPr>
          <p:cNvSpPr txBox="1"/>
          <p:nvPr/>
        </p:nvSpPr>
        <p:spPr>
          <a:xfrm rot="16200000">
            <a:off x="1089959" y="2549189"/>
            <a:ext cx="67310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ACE-align-MNN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DF20C8F-DC4A-CFCA-AE98-9E51A6669B66}"/>
              </a:ext>
            </a:extLst>
          </p:cNvPr>
          <p:cNvSpPr txBox="1"/>
          <p:nvPr/>
        </p:nvSpPr>
        <p:spPr>
          <a:xfrm rot="16200000">
            <a:off x="1095783" y="2620308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ACE-align-Scanorama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49F23B7-5AC2-DB32-4DDF-526F5CE0E059}"/>
              </a:ext>
            </a:extLst>
          </p:cNvPr>
          <p:cNvSpPr txBox="1"/>
          <p:nvPr/>
        </p:nvSpPr>
        <p:spPr>
          <a:xfrm rot="16200000">
            <a:off x="1183036" y="2620308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ACE-align-Harmony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C9B8767-C516-1A9A-7926-36C012B62945}"/>
              </a:ext>
            </a:extLst>
          </p:cNvPr>
          <p:cNvSpPr txBox="1"/>
          <p:nvPr/>
        </p:nvSpPr>
        <p:spPr>
          <a:xfrm rot="16200000">
            <a:off x="1267749" y="2620308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ACE-spec-MNN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73E3DE39-0ABB-82A5-826A-61C747FBCE9D}"/>
              </a:ext>
            </a:extLst>
          </p:cNvPr>
          <p:cNvSpPr txBox="1"/>
          <p:nvPr/>
        </p:nvSpPr>
        <p:spPr>
          <a:xfrm rot="16200000">
            <a:off x="1386255" y="2586364"/>
            <a:ext cx="74745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ACE-spec-Scanorama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9A6AA20-4DDB-8C74-5782-A96C6DE55DBA}"/>
              </a:ext>
            </a:extLst>
          </p:cNvPr>
          <p:cNvSpPr txBox="1"/>
          <p:nvPr/>
        </p:nvSpPr>
        <p:spPr>
          <a:xfrm rot="16200000">
            <a:off x="1434640" y="2620308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ACE-spec-Harmony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B8A7C95D-1F6F-C738-84E9-2E4EA5FA9950}"/>
              </a:ext>
            </a:extLst>
          </p:cNvPr>
          <p:cNvSpPr/>
          <p:nvPr/>
        </p:nvSpPr>
        <p:spPr>
          <a:xfrm rot="16200000">
            <a:off x="1950865" y="2327504"/>
            <a:ext cx="695658" cy="7988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endParaRPr lang="zh-CN" altLang="en-US" sz="160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7CCF3C64-AD9C-3FFE-F9C0-2E6D011F692C}"/>
              </a:ext>
            </a:extLst>
          </p:cNvPr>
          <p:cNvSpPr txBox="1"/>
          <p:nvPr/>
        </p:nvSpPr>
        <p:spPr>
          <a:xfrm rot="16200000">
            <a:off x="1527127" y="2620308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CLUE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CC8037F-D117-DA7E-9AAF-820748DB957C}"/>
              </a:ext>
            </a:extLst>
          </p:cNvPr>
          <p:cNvSpPr txBox="1"/>
          <p:nvPr/>
        </p:nvSpPr>
        <p:spPr>
          <a:xfrm rot="16200000">
            <a:off x="1737633" y="2488976"/>
            <a:ext cx="55268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CLUE-Harmony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7BB4A809-3ADE-62A4-B2E8-C14FA4C25145}"/>
              </a:ext>
            </a:extLst>
          </p:cNvPr>
          <p:cNvSpPr txBox="1"/>
          <p:nvPr/>
        </p:nvSpPr>
        <p:spPr>
          <a:xfrm rot="16200000">
            <a:off x="1782451" y="2549189"/>
            <a:ext cx="67310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MatchCLOT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15F9A3D2-49A2-7778-7E39-C37F29C7446C}"/>
              </a:ext>
            </a:extLst>
          </p:cNvPr>
          <p:cNvSpPr txBox="1"/>
          <p:nvPr/>
        </p:nvSpPr>
        <p:spPr>
          <a:xfrm rot="16200000">
            <a:off x="2023111" y="2388012"/>
            <a:ext cx="350748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Cobolt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880D51C-B059-86B2-9725-7BAFEB881707}"/>
              </a:ext>
            </a:extLst>
          </p:cNvPr>
          <p:cNvSpPr txBox="1"/>
          <p:nvPr/>
        </p:nvSpPr>
        <p:spPr>
          <a:xfrm rot="16200000">
            <a:off x="1974474" y="2513742"/>
            <a:ext cx="602208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Cobolt</a:t>
            </a:r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-Harmony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F9C91A0A-ABE8-16FE-5AFB-18C6116EF3FB}"/>
              </a:ext>
            </a:extLst>
          </p:cNvPr>
          <p:cNvSpPr txBox="1"/>
          <p:nvPr/>
        </p:nvSpPr>
        <p:spPr>
          <a:xfrm rot="16200000">
            <a:off x="1960241" y="2620308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tabMap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8203FAA3-F2B2-3944-9092-34D45C90C11F}"/>
              </a:ext>
            </a:extLst>
          </p:cNvPr>
          <p:cNvSpPr txBox="1"/>
          <p:nvPr/>
        </p:nvSpPr>
        <p:spPr>
          <a:xfrm rot="16200000">
            <a:off x="2115925" y="2549187"/>
            <a:ext cx="67310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tabMap</a:t>
            </a:r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-Harmony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76D050BD-9D0C-8FA1-91A0-6FD1265570C3}"/>
              </a:ext>
            </a:extLst>
          </p:cNvPr>
          <p:cNvSpPr txBox="1"/>
          <p:nvPr/>
        </p:nvSpPr>
        <p:spPr>
          <a:xfrm rot="16200000">
            <a:off x="2139832" y="2620308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cMoMaT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0B69D5CB-9449-D391-8C30-6C0DD99C888F}"/>
              </a:ext>
            </a:extLst>
          </p:cNvPr>
          <p:cNvSpPr txBox="1"/>
          <p:nvPr/>
        </p:nvSpPr>
        <p:spPr>
          <a:xfrm rot="16200000">
            <a:off x="2220055" y="2620306"/>
            <a:ext cx="815340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cMoMaT</a:t>
            </a:r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-Harmony</a:t>
            </a:r>
            <a:endParaRPr lang="zh-CN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6B18FF47-99DA-902C-984E-7456D1872B49}"/>
              </a:ext>
            </a:extLst>
          </p:cNvPr>
          <p:cNvGrpSpPr/>
          <p:nvPr/>
        </p:nvGrpSpPr>
        <p:grpSpPr>
          <a:xfrm>
            <a:off x="3416811" y="2271800"/>
            <a:ext cx="1348537" cy="839804"/>
            <a:chOff x="1595757" y="4809204"/>
            <a:chExt cx="1348537" cy="839804"/>
          </a:xfrm>
        </p:grpSpPr>
        <p:grpSp>
          <p:nvGrpSpPr>
            <p:cNvPr id="100" name="组合 99">
              <a:extLst>
                <a:ext uri="{FF2B5EF4-FFF2-40B4-BE49-F238E27FC236}">
                  <a16:creationId xmlns:a16="http://schemas.microsoft.com/office/drawing/2014/main" id="{871299FF-09D0-BF90-4A75-C6F73700040E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id="{A5DF2F31-1CAB-0082-E980-BEA55D47649D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1D55D3AC-497E-8379-ADD7-460502E3A180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AB207CE6-615C-1063-F050-02CEC7FFC195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CCAAAA80-08BE-9CEB-443B-59AC5E508728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16958ED7-F432-ABBE-4260-5FE8F8AE686F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4FB078B0-AF9B-5405-D5BA-879AFCFFD370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B46F5BC2-8674-998B-6CFB-BF3A2C4F88A2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6A2E0440-DE33-9E12-5326-FBA0D34F6227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9439E828-E6E1-F985-BEEA-7FDF0BC26DA7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2C60381D-F3CF-36A1-901E-671CE50C7FD4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112AAACB-1A0A-01C7-D0AF-D1D09437181D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50666ED2-8CB6-B11F-2612-FAF43E057C0A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DE4470CF-DCEA-8747-1233-B0E5DE8BFB22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C90CA0D6-46EA-B747-D4CD-24F02BFC1BEA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E0D40AA3-4D72-1ACD-6B6F-645358D4DA53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B3BFBA24-25A2-ECDF-18EB-17BF4A0DDA44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816AF76B-16C6-5871-4367-023704F7F336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FCCBE360-E0AB-9DB8-CB17-316A12AFFB1D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B4E91D37-B3CE-13B6-A22E-E48E1311716A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组合 119">
            <a:extLst>
              <a:ext uri="{FF2B5EF4-FFF2-40B4-BE49-F238E27FC236}">
                <a16:creationId xmlns:a16="http://schemas.microsoft.com/office/drawing/2014/main" id="{456F0217-FFF0-4F1C-428F-736C0E435E8E}"/>
              </a:ext>
            </a:extLst>
          </p:cNvPr>
          <p:cNvGrpSpPr/>
          <p:nvPr/>
        </p:nvGrpSpPr>
        <p:grpSpPr>
          <a:xfrm>
            <a:off x="5482805" y="2274340"/>
            <a:ext cx="1348537" cy="839804"/>
            <a:chOff x="1595757" y="4809204"/>
            <a:chExt cx="1348537" cy="839804"/>
          </a:xfrm>
        </p:grpSpPr>
        <p:grpSp>
          <p:nvGrpSpPr>
            <p:cNvPr id="121" name="组合 120">
              <a:extLst>
                <a:ext uri="{FF2B5EF4-FFF2-40B4-BE49-F238E27FC236}">
                  <a16:creationId xmlns:a16="http://schemas.microsoft.com/office/drawing/2014/main" id="{2BA9F66B-7CCF-A775-30FC-A241B1007604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139" name="矩形 138">
                <a:extLst>
                  <a:ext uri="{FF2B5EF4-FFF2-40B4-BE49-F238E27FC236}">
                    <a16:creationId xmlns:a16="http://schemas.microsoft.com/office/drawing/2014/main" id="{A733AF3D-06C4-6E47-345B-A8C9D8990A36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9337A063-2193-023E-0172-7BCA44BCC3E8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2" name="矩形 121">
              <a:extLst>
                <a:ext uri="{FF2B5EF4-FFF2-40B4-BE49-F238E27FC236}">
                  <a16:creationId xmlns:a16="http://schemas.microsoft.com/office/drawing/2014/main" id="{25FB3C1E-B1C1-87CA-A4CA-F3F112AE46AD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3A856FBA-1EA0-1B13-D3D8-C33061D4EDDB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24C5763D-BDF5-6F82-7700-B01763F77DBD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538CD02A-6EB1-C65F-3E67-F0E144FF369B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AE0608A5-E1DA-DA78-66C8-1ADDD3B57666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69327A47-971F-B43B-9795-CFBE4A562912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4F51849A-3F3A-D59C-E4E9-5B93AF2EE800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矩形 128">
              <a:extLst>
                <a:ext uri="{FF2B5EF4-FFF2-40B4-BE49-F238E27FC236}">
                  <a16:creationId xmlns:a16="http://schemas.microsoft.com/office/drawing/2014/main" id="{75F91BF3-27DC-98CF-E5E3-BD21EDBA9411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E87BC8AC-AB13-5D35-3866-F6928DBD6CF6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D6BC0E04-3C00-1031-95ED-07F01F229517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FEFB2B91-1C81-4FFB-C143-A9B0605B3478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8FFFC863-2196-AD91-5465-4C516ACFD9A1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17F8FB81-2850-2524-0617-774E330CA0C0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931135D0-10A0-0B18-FC69-2DA6723F8524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BF061438-DB9E-7EB0-AC53-C7AF123FBD11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3AE79792-FFE6-9D14-A623-738FAC2F20FE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88148569-8E44-EB99-B706-41417F4FFB77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9" name="组合 158">
            <a:extLst>
              <a:ext uri="{FF2B5EF4-FFF2-40B4-BE49-F238E27FC236}">
                <a16:creationId xmlns:a16="http://schemas.microsoft.com/office/drawing/2014/main" id="{6968D368-2664-E96D-868D-EA38ED8D65AF}"/>
              </a:ext>
            </a:extLst>
          </p:cNvPr>
          <p:cNvGrpSpPr/>
          <p:nvPr/>
        </p:nvGrpSpPr>
        <p:grpSpPr>
          <a:xfrm>
            <a:off x="1377313" y="4633588"/>
            <a:ext cx="1348537" cy="839804"/>
            <a:chOff x="1595757" y="4809204"/>
            <a:chExt cx="1348537" cy="839804"/>
          </a:xfrm>
        </p:grpSpPr>
        <p:grpSp>
          <p:nvGrpSpPr>
            <p:cNvPr id="160" name="组合 159">
              <a:extLst>
                <a:ext uri="{FF2B5EF4-FFF2-40B4-BE49-F238E27FC236}">
                  <a16:creationId xmlns:a16="http://schemas.microsoft.com/office/drawing/2014/main" id="{87F1F360-EF3F-0D8A-9DFD-FAA291D5E0D4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178" name="矩形 177">
                <a:extLst>
                  <a:ext uri="{FF2B5EF4-FFF2-40B4-BE49-F238E27FC236}">
                    <a16:creationId xmlns:a16="http://schemas.microsoft.com/office/drawing/2014/main" id="{721C2AA2-43A7-C122-A961-19395785B9F7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E42BEA42-CB98-B8F0-9C7C-F6806B22B1F9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1" name="矩形 160">
              <a:extLst>
                <a:ext uri="{FF2B5EF4-FFF2-40B4-BE49-F238E27FC236}">
                  <a16:creationId xmlns:a16="http://schemas.microsoft.com/office/drawing/2014/main" id="{8D717FCF-B252-C401-71BD-07167C6476C7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4B08650A-4285-07AE-171E-CC671754E2AC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59887E8C-23B5-E0E4-AD3C-2D5BDBF9E03E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本框 163">
              <a:extLst>
                <a:ext uri="{FF2B5EF4-FFF2-40B4-BE49-F238E27FC236}">
                  <a16:creationId xmlns:a16="http://schemas.microsoft.com/office/drawing/2014/main" id="{61180CF2-F717-E850-67DD-CA5C8019A1A2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9C25DFC6-C2C5-05A8-B056-7597E2FE9D69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165">
              <a:extLst>
                <a:ext uri="{FF2B5EF4-FFF2-40B4-BE49-F238E27FC236}">
                  <a16:creationId xmlns:a16="http://schemas.microsoft.com/office/drawing/2014/main" id="{5F19AB6C-F8FA-12AD-C796-1638D6F134D3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文本框 166">
              <a:extLst>
                <a:ext uri="{FF2B5EF4-FFF2-40B4-BE49-F238E27FC236}">
                  <a16:creationId xmlns:a16="http://schemas.microsoft.com/office/drawing/2014/main" id="{C3810009-CF9B-AD04-44EC-01C07A2B4E2F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矩形 167">
              <a:extLst>
                <a:ext uri="{FF2B5EF4-FFF2-40B4-BE49-F238E27FC236}">
                  <a16:creationId xmlns:a16="http://schemas.microsoft.com/office/drawing/2014/main" id="{D35A65A6-48E7-71AC-47C1-7A225AE1F627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435D2745-5525-0BAF-7D30-8576E3AB4C33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A11433A3-CC3C-6C6F-FFE1-AB5D2A924808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文本框 170">
              <a:extLst>
                <a:ext uri="{FF2B5EF4-FFF2-40B4-BE49-F238E27FC236}">
                  <a16:creationId xmlns:a16="http://schemas.microsoft.com/office/drawing/2014/main" id="{163780C9-76B9-BB37-188E-9F16ABD1CB33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FF38B1CF-5210-55ED-16EB-56E636046803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64EB84F5-554F-D74B-24C3-F8FD95F9D17D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4B427C52-7DCD-FAF2-3E52-4F49FFA4FA01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CFE61AEF-A563-81B5-2715-92964C345D8E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4ED8EAB1-708E-21AD-8635-AE4F51400490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文本框 176">
              <a:extLst>
                <a:ext uri="{FF2B5EF4-FFF2-40B4-BE49-F238E27FC236}">
                  <a16:creationId xmlns:a16="http://schemas.microsoft.com/office/drawing/2014/main" id="{C83D20E7-651E-A60D-0215-A18CCE787E1C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0" name="组合 179">
            <a:extLst>
              <a:ext uri="{FF2B5EF4-FFF2-40B4-BE49-F238E27FC236}">
                <a16:creationId xmlns:a16="http://schemas.microsoft.com/office/drawing/2014/main" id="{1840EF9B-1866-202B-ED7C-6019CD5139FB}"/>
              </a:ext>
            </a:extLst>
          </p:cNvPr>
          <p:cNvGrpSpPr/>
          <p:nvPr/>
        </p:nvGrpSpPr>
        <p:grpSpPr>
          <a:xfrm>
            <a:off x="3416811" y="4638668"/>
            <a:ext cx="1348537" cy="839804"/>
            <a:chOff x="1595757" y="4809204"/>
            <a:chExt cx="1348537" cy="839804"/>
          </a:xfrm>
        </p:grpSpPr>
        <p:grpSp>
          <p:nvGrpSpPr>
            <p:cNvPr id="181" name="组合 180">
              <a:extLst>
                <a:ext uri="{FF2B5EF4-FFF2-40B4-BE49-F238E27FC236}">
                  <a16:creationId xmlns:a16="http://schemas.microsoft.com/office/drawing/2014/main" id="{07AE9BC2-9AF1-C526-EA02-244605F225F5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199" name="矩形 198">
                <a:extLst>
                  <a:ext uri="{FF2B5EF4-FFF2-40B4-BE49-F238E27FC236}">
                    <a16:creationId xmlns:a16="http://schemas.microsoft.com/office/drawing/2014/main" id="{5A194F58-92C4-CB72-FDCE-61E9FC9E4A98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:a16="http://schemas.microsoft.com/office/drawing/2014/main" id="{4E65242F-9669-A999-8F02-6A382FD1C324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2" name="矩形 181">
              <a:extLst>
                <a:ext uri="{FF2B5EF4-FFF2-40B4-BE49-F238E27FC236}">
                  <a16:creationId xmlns:a16="http://schemas.microsoft.com/office/drawing/2014/main" id="{2465536D-9DC5-CE98-089D-0D223FF329B0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BD079C7A-F0DD-10A9-F828-A1264396C212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51E254F6-9787-D40A-5F04-DF8CEFDD9A73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文本框 184">
              <a:extLst>
                <a:ext uri="{FF2B5EF4-FFF2-40B4-BE49-F238E27FC236}">
                  <a16:creationId xmlns:a16="http://schemas.microsoft.com/office/drawing/2014/main" id="{1D17B9CC-1E00-2BD1-63F1-40A8E5B099FA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73518F88-D697-7078-3FFC-7F7BBF17D341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DDF9172A-EE15-05FD-2CD2-E959E45B9AA6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7803E13E-F19B-FDD8-CD18-82094BE8124B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矩形 188">
              <a:extLst>
                <a:ext uri="{FF2B5EF4-FFF2-40B4-BE49-F238E27FC236}">
                  <a16:creationId xmlns:a16="http://schemas.microsoft.com/office/drawing/2014/main" id="{814B2DDA-9344-5DA3-0ADF-E25093D6FF07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18267C07-7D9F-0181-8E31-C2F6950E1F00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DEDFA6D6-A437-ADBB-5350-6B09DB6C1E3A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文本框 191">
              <a:extLst>
                <a:ext uri="{FF2B5EF4-FFF2-40B4-BE49-F238E27FC236}">
                  <a16:creationId xmlns:a16="http://schemas.microsoft.com/office/drawing/2014/main" id="{9A917197-DCDC-3FE7-DFE1-D6C1C7C8AEAD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8450B917-8031-32E2-DB88-4BADDAC107C1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5F2F8208-C545-81B8-1D4D-4C9F8C80F2EB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文本框 194">
              <a:extLst>
                <a:ext uri="{FF2B5EF4-FFF2-40B4-BE49-F238E27FC236}">
                  <a16:creationId xmlns:a16="http://schemas.microsoft.com/office/drawing/2014/main" id="{5AECFC2A-79C6-DC1E-9C37-BF9CA6195C47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文本框 195">
              <a:extLst>
                <a:ext uri="{FF2B5EF4-FFF2-40B4-BE49-F238E27FC236}">
                  <a16:creationId xmlns:a16="http://schemas.microsoft.com/office/drawing/2014/main" id="{7479F207-B87E-996B-0525-4AFF0A0795B3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43A4B03B-1B28-B8D4-39E6-12E297892C8D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文本框 197">
              <a:extLst>
                <a:ext uri="{FF2B5EF4-FFF2-40B4-BE49-F238E27FC236}">
                  <a16:creationId xmlns:a16="http://schemas.microsoft.com/office/drawing/2014/main" id="{5D26F13C-C77D-3FFA-CB05-986E6F22A851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1" name="组合 200">
            <a:extLst>
              <a:ext uri="{FF2B5EF4-FFF2-40B4-BE49-F238E27FC236}">
                <a16:creationId xmlns:a16="http://schemas.microsoft.com/office/drawing/2014/main" id="{7A6518D8-1BDE-02DA-5280-E643F8FC74B9}"/>
              </a:ext>
            </a:extLst>
          </p:cNvPr>
          <p:cNvGrpSpPr/>
          <p:nvPr/>
        </p:nvGrpSpPr>
        <p:grpSpPr>
          <a:xfrm>
            <a:off x="5499611" y="4638668"/>
            <a:ext cx="1348537" cy="839804"/>
            <a:chOff x="1595757" y="4809204"/>
            <a:chExt cx="1348537" cy="839804"/>
          </a:xfrm>
        </p:grpSpPr>
        <p:grpSp>
          <p:nvGrpSpPr>
            <p:cNvPr id="202" name="组合 201">
              <a:extLst>
                <a:ext uri="{FF2B5EF4-FFF2-40B4-BE49-F238E27FC236}">
                  <a16:creationId xmlns:a16="http://schemas.microsoft.com/office/drawing/2014/main" id="{4A2B2097-7308-31F0-1E30-EC23E79D7108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220" name="矩形 219">
                <a:extLst>
                  <a:ext uri="{FF2B5EF4-FFF2-40B4-BE49-F238E27FC236}">
                    <a16:creationId xmlns:a16="http://schemas.microsoft.com/office/drawing/2014/main" id="{9A2AD68F-5312-4F2F-9FD5-ADF454109A11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ADF22F6F-6C93-054C-B55D-A1F5F8DEC097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3" name="矩形 202">
              <a:extLst>
                <a:ext uri="{FF2B5EF4-FFF2-40B4-BE49-F238E27FC236}">
                  <a16:creationId xmlns:a16="http://schemas.microsoft.com/office/drawing/2014/main" id="{37B36F7F-4597-8125-41FE-90C1C56AB485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04" name="文本框 203">
              <a:extLst>
                <a:ext uri="{FF2B5EF4-FFF2-40B4-BE49-F238E27FC236}">
                  <a16:creationId xmlns:a16="http://schemas.microsoft.com/office/drawing/2014/main" id="{31A1FCCC-78CA-E973-8E87-12C88339CAE0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文本框 204">
              <a:extLst>
                <a:ext uri="{FF2B5EF4-FFF2-40B4-BE49-F238E27FC236}">
                  <a16:creationId xmlns:a16="http://schemas.microsoft.com/office/drawing/2014/main" id="{57148460-7D3A-1EF4-6FB0-BC7AF35393D8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文本框 205">
              <a:extLst>
                <a:ext uri="{FF2B5EF4-FFF2-40B4-BE49-F238E27FC236}">
                  <a16:creationId xmlns:a16="http://schemas.microsoft.com/office/drawing/2014/main" id="{CDEA9005-577A-8C60-D1B8-0C2577F5B564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文本框 206">
              <a:extLst>
                <a:ext uri="{FF2B5EF4-FFF2-40B4-BE49-F238E27FC236}">
                  <a16:creationId xmlns:a16="http://schemas.microsoft.com/office/drawing/2014/main" id="{FF4684DB-6F32-5359-1A9F-D8E4189F214B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文本框 207">
              <a:extLst>
                <a:ext uri="{FF2B5EF4-FFF2-40B4-BE49-F238E27FC236}">
                  <a16:creationId xmlns:a16="http://schemas.microsoft.com/office/drawing/2014/main" id="{AB3AA1A3-601F-33FF-E326-845DD78491F4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C10960FD-8D6D-909B-24BA-1950ED2BC221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矩形 209">
              <a:extLst>
                <a:ext uri="{FF2B5EF4-FFF2-40B4-BE49-F238E27FC236}">
                  <a16:creationId xmlns:a16="http://schemas.microsoft.com/office/drawing/2014/main" id="{ED159F9A-8584-2C89-5025-5C9522203170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11" name="文本框 210">
              <a:extLst>
                <a:ext uri="{FF2B5EF4-FFF2-40B4-BE49-F238E27FC236}">
                  <a16:creationId xmlns:a16="http://schemas.microsoft.com/office/drawing/2014/main" id="{2AE64FE6-F98A-5544-D8DC-7320B6B7F226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9082951D-BC4C-1713-3317-08487296A532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021FD796-7B34-E679-FAB8-150098D369A9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FC323E9E-F686-92B8-B418-568916A38228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65310736-55DC-7B36-8860-7EC06FA96DF5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文本框 215">
              <a:extLst>
                <a:ext uri="{FF2B5EF4-FFF2-40B4-BE49-F238E27FC236}">
                  <a16:creationId xmlns:a16="http://schemas.microsoft.com/office/drawing/2014/main" id="{A52D4B9E-8AD5-E01A-3AD6-4BE3FD436597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769AB965-2EFE-CC0E-2FE1-566B138483C6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E9625A09-568C-3A6D-D117-7B21D11A0B0B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A059C0B4-E647-1489-F1DA-F25C37BD3344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2" name="组合 221">
            <a:extLst>
              <a:ext uri="{FF2B5EF4-FFF2-40B4-BE49-F238E27FC236}">
                <a16:creationId xmlns:a16="http://schemas.microsoft.com/office/drawing/2014/main" id="{8652EDD4-B43B-AF31-7A08-F13DFF78E6E4}"/>
              </a:ext>
            </a:extLst>
          </p:cNvPr>
          <p:cNvGrpSpPr/>
          <p:nvPr/>
        </p:nvGrpSpPr>
        <p:grpSpPr>
          <a:xfrm>
            <a:off x="1159064" y="7596269"/>
            <a:ext cx="1348537" cy="842344"/>
            <a:chOff x="1595757" y="4809204"/>
            <a:chExt cx="1348537" cy="842344"/>
          </a:xfrm>
        </p:grpSpPr>
        <p:grpSp>
          <p:nvGrpSpPr>
            <p:cNvPr id="223" name="组合 222">
              <a:extLst>
                <a:ext uri="{FF2B5EF4-FFF2-40B4-BE49-F238E27FC236}">
                  <a16:creationId xmlns:a16="http://schemas.microsoft.com/office/drawing/2014/main" id="{C6D374DF-C8E2-B0F1-17C6-3210F1F17237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241" name="矩形 240">
                <a:extLst>
                  <a:ext uri="{FF2B5EF4-FFF2-40B4-BE49-F238E27FC236}">
                    <a16:creationId xmlns:a16="http://schemas.microsoft.com/office/drawing/2014/main" id="{5C2BABC2-BAD1-6BC0-4DB3-3C1D0EEE5740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42" name="文本框 241">
                <a:extLst>
                  <a:ext uri="{FF2B5EF4-FFF2-40B4-BE49-F238E27FC236}">
                    <a16:creationId xmlns:a16="http://schemas.microsoft.com/office/drawing/2014/main" id="{3A02A375-CFFD-5D1F-1D04-1FC0A651C859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4" name="矩形 223">
              <a:extLst>
                <a:ext uri="{FF2B5EF4-FFF2-40B4-BE49-F238E27FC236}">
                  <a16:creationId xmlns:a16="http://schemas.microsoft.com/office/drawing/2014/main" id="{E6D9751D-C480-1A36-EA6A-895429DD4A11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64FE96A5-11FF-A490-57E4-FD03BA6CBBFC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4783E143-F349-9AB5-6DBD-2EECAF1CB577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913B74D0-CB46-9993-2639-92C8B8B7EB1B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8E880D26-4D61-4608-2301-404D04CC55BC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5B796AC6-E4E1-BDBE-7AD9-E762D20586E4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59D7EC10-925F-6608-ADD5-600C1C6151EA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矩形 230">
              <a:extLst>
                <a:ext uri="{FF2B5EF4-FFF2-40B4-BE49-F238E27FC236}">
                  <a16:creationId xmlns:a16="http://schemas.microsoft.com/office/drawing/2014/main" id="{84AC1D08-4080-68DE-7726-BF9D77F8C7C9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F2DCF586-0FF3-6558-4213-03EB028ECC89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119258A3-4462-D03B-1039-66E784AE07C4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D21CC0FA-7A6E-E87C-5C96-E472809603A7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文本框 234">
              <a:extLst>
                <a:ext uri="{FF2B5EF4-FFF2-40B4-BE49-F238E27FC236}">
                  <a16:creationId xmlns:a16="http://schemas.microsoft.com/office/drawing/2014/main" id="{54741024-79AC-804F-DDC5-1894DD40D52A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文本框 235">
              <a:extLst>
                <a:ext uri="{FF2B5EF4-FFF2-40B4-BE49-F238E27FC236}">
                  <a16:creationId xmlns:a16="http://schemas.microsoft.com/office/drawing/2014/main" id="{8986626B-79C4-5424-22B5-BE2B384B8173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文本框 236">
              <a:extLst>
                <a:ext uri="{FF2B5EF4-FFF2-40B4-BE49-F238E27FC236}">
                  <a16:creationId xmlns:a16="http://schemas.microsoft.com/office/drawing/2014/main" id="{5EC43D6A-9866-0BC2-DA45-F0EDD2B1CDD6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F87B25B2-D8C9-599F-034C-707A7A92B374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0F638D3B-279E-EA40-8C7F-29BE2FC4038F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D851DE74-6531-70F7-4722-36EBB4814D4B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3" name="组合 242">
            <a:extLst>
              <a:ext uri="{FF2B5EF4-FFF2-40B4-BE49-F238E27FC236}">
                <a16:creationId xmlns:a16="http://schemas.microsoft.com/office/drawing/2014/main" id="{CDA1C744-7DD5-5809-D082-4559DDDE043F}"/>
              </a:ext>
            </a:extLst>
          </p:cNvPr>
          <p:cNvGrpSpPr/>
          <p:nvPr/>
        </p:nvGrpSpPr>
        <p:grpSpPr>
          <a:xfrm>
            <a:off x="2774431" y="7601984"/>
            <a:ext cx="1348537" cy="842344"/>
            <a:chOff x="1595757" y="4809204"/>
            <a:chExt cx="1348537" cy="842344"/>
          </a:xfrm>
        </p:grpSpPr>
        <p:grpSp>
          <p:nvGrpSpPr>
            <p:cNvPr id="244" name="组合 243">
              <a:extLst>
                <a:ext uri="{FF2B5EF4-FFF2-40B4-BE49-F238E27FC236}">
                  <a16:creationId xmlns:a16="http://schemas.microsoft.com/office/drawing/2014/main" id="{E6B2B5F3-8018-F7C6-218D-616D744A1B5F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262" name="矩形 261">
                <a:extLst>
                  <a:ext uri="{FF2B5EF4-FFF2-40B4-BE49-F238E27FC236}">
                    <a16:creationId xmlns:a16="http://schemas.microsoft.com/office/drawing/2014/main" id="{F27F4583-F1C1-2E38-CE3C-CC3CFF6A7F8B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63" name="文本框 262">
                <a:extLst>
                  <a:ext uri="{FF2B5EF4-FFF2-40B4-BE49-F238E27FC236}">
                    <a16:creationId xmlns:a16="http://schemas.microsoft.com/office/drawing/2014/main" id="{148667FC-AC60-AFED-3E7C-A96D8AB97E98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5" name="矩形 244">
              <a:extLst>
                <a:ext uri="{FF2B5EF4-FFF2-40B4-BE49-F238E27FC236}">
                  <a16:creationId xmlns:a16="http://schemas.microsoft.com/office/drawing/2014/main" id="{7B3396E9-9DF6-0648-953D-928080F4E19A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46" name="文本框 245">
              <a:extLst>
                <a:ext uri="{FF2B5EF4-FFF2-40B4-BE49-F238E27FC236}">
                  <a16:creationId xmlns:a16="http://schemas.microsoft.com/office/drawing/2014/main" id="{35639B33-7D3E-76DE-3576-6617E39142CF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文本框 246">
              <a:extLst>
                <a:ext uri="{FF2B5EF4-FFF2-40B4-BE49-F238E27FC236}">
                  <a16:creationId xmlns:a16="http://schemas.microsoft.com/office/drawing/2014/main" id="{7F8CF8A6-E165-6D19-5844-EF903EEEB113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文本框 247">
              <a:extLst>
                <a:ext uri="{FF2B5EF4-FFF2-40B4-BE49-F238E27FC236}">
                  <a16:creationId xmlns:a16="http://schemas.microsoft.com/office/drawing/2014/main" id="{49E9C57B-659E-61AE-1E55-2281D6ECF611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文本框 248">
              <a:extLst>
                <a:ext uri="{FF2B5EF4-FFF2-40B4-BE49-F238E27FC236}">
                  <a16:creationId xmlns:a16="http://schemas.microsoft.com/office/drawing/2014/main" id="{5BFD1E1B-5FF3-B79F-C242-E258B8B89CDB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文本框 249">
              <a:extLst>
                <a:ext uri="{FF2B5EF4-FFF2-40B4-BE49-F238E27FC236}">
                  <a16:creationId xmlns:a16="http://schemas.microsoft.com/office/drawing/2014/main" id="{3B1AC8F2-F2BB-E43D-E7EF-236931E1AAE5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文本框 250">
              <a:extLst>
                <a:ext uri="{FF2B5EF4-FFF2-40B4-BE49-F238E27FC236}">
                  <a16:creationId xmlns:a16="http://schemas.microsoft.com/office/drawing/2014/main" id="{7EDBF7AF-FB9D-4366-F41D-E3266465DEC1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矩形 251">
              <a:extLst>
                <a:ext uri="{FF2B5EF4-FFF2-40B4-BE49-F238E27FC236}">
                  <a16:creationId xmlns:a16="http://schemas.microsoft.com/office/drawing/2014/main" id="{72787B2B-A765-553D-3CED-8F984341E207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53" name="文本框 252">
              <a:extLst>
                <a:ext uri="{FF2B5EF4-FFF2-40B4-BE49-F238E27FC236}">
                  <a16:creationId xmlns:a16="http://schemas.microsoft.com/office/drawing/2014/main" id="{ECD0EB19-B8E8-DA6A-0527-09BE7C9F764B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文本框 253">
              <a:extLst>
                <a:ext uri="{FF2B5EF4-FFF2-40B4-BE49-F238E27FC236}">
                  <a16:creationId xmlns:a16="http://schemas.microsoft.com/office/drawing/2014/main" id="{A963E098-9FB7-B23C-8A71-92363D76069D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文本框 254">
              <a:extLst>
                <a:ext uri="{FF2B5EF4-FFF2-40B4-BE49-F238E27FC236}">
                  <a16:creationId xmlns:a16="http://schemas.microsoft.com/office/drawing/2014/main" id="{49B4709C-1D94-C6C1-E8FB-9F4171A19D82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id="{D68379C5-8892-1392-0981-C0346BF0AC9A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文本框 256">
              <a:extLst>
                <a:ext uri="{FF2B5EF4-FFF2-40B4-BE49-F238E27FC236}">
                  <a16:creationId xmlns:a16="http://schemas.microsoft.com/office/drawing/2014/main" id="{88DB73F6-526B-5B9C-A4B9-182BE17523F2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文本框 257">
              <a:extLst>
                <a:ext uri="{FF2B5EF4-FFF2-40B4-BE49-F238E27FC236}">
                  <a16:creationId xmlns:a16="http://schemas.microsoft.com/office/drawing/2014/main" id="{5F425E4F-3ABD-9042-62DB-FD68D7EB91EF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文本框 258">
              <a:extLst>
                <a:ext uri="{FF2B5EF4-FFF2-40B4-BE49-F238E27FC236}">
                  <a16:creationId xmlns:a16="http://schemas.microsoft.com/office/drawing/2014/main" id="{8C247464-19ED-AED1-31D1-C4543543D3A6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文本框 259">
              <a:extLst>
                <a:ext uri="{FF2B5EF4-FFF2-40B4-BE49-F238E27FC236}">
                  <a16:creationId xmlns:a16="http://schemas.microsoft.com/office/drawing/2014/main" id="{E3AACA8C-E39B-F2CC-3871-100532DC91F4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文本框 260">
              <a:extLst>
                <a:ext uri="{FF2B5EF4-FFF2-40B4-BE49-F238E27FC236}">
                  <a16:creationId xmlns:a16="http://schemas.microsoft.com/office/drawing/2014/main" id="{BB40CD77-23D4-C579-430E-2D01A4FA661D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4" name="组合 263">
            <a:extLst>
              <a:ext uri="{FF2B5EF4-FFF2-40B4-BE49-F238E27FC236}">
                <a16:creationId xmlns:a16="http://schemas.microsoft.com/office/drawing/2014/main" id="{40255B84-95BA-464B-99B8-30FE3BF5971D}"/>
              </a:ext>
            </a:extLst>
          </p:cNvPr>
          <p:cNvGrpSpPr/>
          <p:nvPr/>
        </p:nvGrpSpPr>
        <p:grpSpPr>
          <a:xfrm>
            <a:off x="4391054" y="7594364"/>
            <a:ext cx="1348537" cy="842344"/>
            <a:chOff x="1595757" y="4809204"/>
            <a:chExt cx="1348537" cy="842344"/>
          </a:xfrm>
        </p:grpSpPr>
        <p:grpSp>
          <p:nvGrpSpPr>
            <p:cNvPr id="265" name="组合 264">
              <a:extLst>
                <a:ext uri="{FF2B5EF4-FFF2-40B4-BE49-F238E27FC236}">
                  <a16:creationId xmlns:a16="http://schemas.microsoft.com/office/drawing/2014/main" id="{4420DA85-F803-6586-6B23-6CA0AB0FF1C3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283" name="矩形 282">
                <a:extLst>
                  <a:ext uri="{FF2B5EF4-FFF2-40B4-BE49-F238E27FC236}">
                    <a16:creationId xmlns:a16="http://schemas.microsoft.com/office/drawing/2014/main" id="{E95D1C85-B9CB-B324-2929-07346A8561F4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84" name="文本框 283">
                <a:extLst>
                  <a:ext uri="{FF2B5EF4-FFF2-40B4-BE49-F238E27FC236}">
                    <a16:creationId xmlns:a16="http://schemas.microsoft.com/office/drawing/2014/main" id="{E5CF125F-67FA-11DF-F5A5-DF6230AFB592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6" name="矩形 265">
              <a:extLst>
                <a:ext uri="{FF2B5EF4-FFF2-40B4-BE49-F238E27FC236}">
                  <a16:creationId xmlns:a16="http://schemas.microsoft.com/office/drawing/2014/main" id="{430EE298-2312-1673-6A06-0559C7067618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67" name="文本框 266">
              <a:extLst>
                <a:ext uri="{FF2B5EF4-FFF2-40B4-BE49-F238E27FC236}">
                  <a16:creationId xmlns:a16="http://schemas.microsoft.com/office/drawing/2014/main" id="{408DD6A5-12E6-7FFC-F9BA-4DC3F62AD2DA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文本框 267">
              <a:extLst>
                <a:ext uri="{FF2B5EF4-FFF2-40B4-BE49-F238E27FC236}">
                  <a16:creationId xmlns:a16="http://schemas.microsoft.com/office/drawing/2014/main" id="{F325BC30-76CF-341A-D8D3-FA3E9ABED127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文本框 268">
              <a:extLst>
                <a:ext uri="{FF2B5EF4-FFF2-40B4-BE49-F238E27FC236}">
                  <a16:creationId xmlns:a16="http://schemas.microsoft.com/office/drawing/2014/main" id="{2915B29C-197A-CFF8-7D38-A46DEFF00F8E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文本框 269">
              <a:extLst>
                <a:ext uri="{FF2B5EF4-FFF2-40B4-BE49-F238E27FC236}">
                  <a16:creationId xmlns:a16="http://schemas.microsoft.com/office/drawing/2014/main" id="{910701DC-B97E-E106-099D-E349ABB3E523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文本框 270">
              <a:extLst>
                <a:ext uri="{FF2B5EF4-FFF2-40B4-BE49-F238E27FC236}">
                  <a16:creationId xmlns:a16="http://schemas.microsoft.com/office/drawing/2014/main" id="{DCCB957E-377B-179C-CE1F-8D95207E7351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文本框 271">
              <a:extLst>
                <a:ext uri="{FF2B5EF4-FFF2-40B4-BE49-F238E27FC236}">
                  <a16:creationId xmlns:a16="http://schemas.microsoft.com/office/drawing/2014/main" id="{487F6A75-90DB-75B6-76FA-6A5B1441CC41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矩形 272">
              <a:extLst>
                <a:ext uri="{FF2B5EF4-FFF2-40B4-BE49-F238E27FC236}">
                  <a16:creationId xmlns:a16="http://schemas.microsoft.com/office/drawing/2014/main" id="{522E7799-6B5A-26E6-6107-19315EDC21DF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74" name="文本框 273">
              <a:extLst>
                <a:ext uri="{FF2B5EF4-FFF2-40B4-BE49-F238E27FC236}">
                  <a16:creationId xmlns:a16="http://schemas.microsoft.com/office/drawing/2014/main" id="{038A66B4-6785-CA8F-13AF-C203723687E0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文本框 274">
              <a:extLst>
                <a:ext uri="{FF2B5EF4-FFF2-40B4-BE49-F238E27FC236}">
                  <a16:creationId xmlns:a16="http://schemas.microsoft.com/office/drawing/2014/main" id="{2A2A6365-726C-CD54-FF19-E783461C6EA4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文本框 275">
              <a:extLst>
                <a:ext uri="{FF2B5EF4-FFF2-40B4-BE49-F238E27FC236}">
                  <a16:creationId xmlns:a16="http://schemas.microsoft.com/office/drawing/2014/main" id="{26038264-F216-DBA7-F800-E3D77E87AD6B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文本框 276">
              <a:extLst>
                <a:ext uri="{FF2B5EF4-FFF2-40B4-BE49-F238E27FC236}">
                  <a16:creationId xmlns:a16="http://schemas.microsoft.com/office/drawing/2014/main" id="{9178B041-C552-33CC-27FE-800DD95FCD2C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文本框 277">
              <a:extLst>
                <a:ext uri="{FF2B5EF4-FFF2-40B4-BE49-F238E27FC236}">
                  <a16:creationId xmlns:a16="http://schemas.microsoft.com/office/drawing/2014/main" id="{80CB0444-6F08-2F01-C0DC-E77D776E7501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文本框 278">
              <a:extLst>
                <a:ext uri="{FF2B5EF4-FFF2-40B4-BE49-F238E27FC236}">
                  <a16:creationId xmlns:a16="http://schemas.microsoft.com/office/drawing/2014/main" id="{2131D225-656D-85BD-55A8-68958D293FFB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文本框 279">
              <a:extLst>
                <a:ext uri="{FF2B5EF4-FFF2-40B4-BE49-F238E27FC236}">
                  <a16:creationId xmlns:a16="http://schemas.microsoft.com/office/drawing/2014/main" id="{69D57821-2FB9-11B1-1F97-FA98458979C4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文本框 280">
              <a:extLst>
                <a:ext uri="{FF2B5EF4-FFF2-40B4-BE49-F238E27FC236}">
                  <a16:creationId xmlns:a16="http://schemas.microsoft.com/office/drawing/2014/main" id="{8E136148-12D3-C678-C145-8FC1843C0E58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文本框 281">
              <a:extLst>
                <a:ext uri="{FF2B5EF4-FFF2-40B4-BE49-F238E27FC236}">
                  <a16:creationId xmlns:a16="http://schemas.microsoft.com/office/drawing/2014/main" id="{8FB5E362-1704-80E3-E3DC-9802A32261AE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5" name="组合 284">
            <a:extLst>
              <a:ext uri="{FF2B5EF4-FFF2-40B4-BE49-F238E27FC236}">
                <a16:creationId xmlns:a16="http://schemas.microsoft.com/office/drawing/2014/main" id="{E15BA4BE-A5FE-DF68-A133-EB7D82393B66}"/>
              </a:ext>
            </a:extLst>
          </p:cNvPr>
          <p:cNvGrpSpPr/>
          <p:nvPr/>
        </p:nvGrpSpPr>
        <p:grpSpPr>
          <a:xfrm>
            <a:off x="6010304" y="7600079"/>
            <a:ext cx="1348537" cy="842344"/>
            <a:chOff x="1595757" y="4809204"/>
            <a:chExt cx="1348537" cy="842344"/>
          </a:xfrm>
        </p:grpSpPr>
        <p:grpSp>
          <p:nvGrpSpPr>
            <p:cNvPr id="286" name="组合 285">
              <a:extLst>
                <a:ext uri="{FF2B5EF4-FFF2-40B4-BE49-F238E27FC236}">
                  <a16:creationId xmlns:a16="http://schemas.microsoft.com/office/drawing/2014/main" id="{DBDAEC49-D7F2-AC6B-5D47-B7D28223E195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304" name="矩形 303">
                <a:extLst>
                  <a:ext uri="{FF2B5EF4-FFF2-40B4-BE49-F238E27FC236}">
                    <a16:creationId xmlns:a16="http://schemas.microsoft.com/office/drawing/2014/main" id="{6AF186D9-07FE-FAAD-E6B4-291B77F5E705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05" name="文本框 304">
                <a:extLst>
                  <a:ext uri="{FF2B5EF4-FFF2-40B4-BE49-F238E27FC236}">
                    <a16:creationId xmlns:a16="http://schemas.microsoft.com/office/drawing/2014/main" id="{FE0A445B-BDD7-F098-E25E-FC9795F03DF5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7" name="矩形 286">
              <a:extLst>
                <a:ext uri="{FF2B5EF4-FFF2-40B4-BE49-F238E27FC236}">
                  <a16:creationId xmlns:a16="http://schemas.microsoft.com/office/drawing/2014/main" id="{B10295A5-A24E-F4F4-83CC-5A793C631A26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88" name="文本框 287">
              <a:extLst>
                <a:ext uri="{FF2B5EF4-FFF2-40B4-BE49-F238E27FC236}">
                  <a16:creationId xmlns:a16="http://schemas.microsoft.com/office/drawing/2014/main" id="{5C8A6E21-677A-33C9-3B99-FA0950851236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文本框 288">
              <a:extLst>
                <a:ext uri="{FF2B5EF4-FFF2-40B4-BE49-F238E27FC236}">
                  <a16:creationId xmlns:a16="http://schemas.microsoft.com/office/drawing/2014/main" id="{8B605BEA-5982-ECB1-28F6-02C642349E9B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0954B104-B566-72AB-B68C-67D0BAF04341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056F8ADD-D532-6B4F-6D2C-6FD52465A2DF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文本框 291">
              <a:extLst>
                <a:ext uri="{FF2B5EF4-FFF2-40B4-BE49-F238E27FC236}">
                  <a16:creationId xmlns:a16="http://schemas.microsoft.com/office/drawing/2014/main" id="{C54F2205-E1CF-A94A-C526-150401F1E616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文本框 292">
              <a:extLst>
                <a:ext uri="{FF2B5EF4-FFF2-40B4-BE49-F238E27FC236}">
                  <a16:creationId xmlns:a16="http://schemas.microsoft.com/office/drawing/2014/main" id="{4DF15FF9-DD3D-E3D7-937A-CCDB8E65A334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矩形 293">
              <a:extLst>
                <a:ext uri="{FF2B5EF4-FFF2-40B4-BE49-F238E27FC236}">
                  <a16:creationId xmlns:a16="http://schemas.microsoft.com/office/drawing/2014/main" id="{A97DC811-5EB5-D234-0F40-691A19DF5FB6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95" name="文本框 294">
              <a:extLst>
                <a:ext uri="{FF2B5EF4-FFF2-40B4-BE49-F238E27FC236}">
                  <a16:creationId xmlns:a16="http://schemas.microsoft.com/office/drawing/2014/main" id="{2F9CB716-9FA5-0C18-9D7A-9C74CEF75BB0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文本框 295">
              <a:extLst>
                <a:ext uri="{FF2B5EF4-FFF2-40B4-BE49-F238E27FC236}">
                  <a16:creationId xmlns:a16="http://schemas.microsoft.com/office/drawing/2014/main" id="{6E8C06B4-983F-E2F9-A3F2-CA7A47F92D57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文本框 296">
              <a:extLst>
                <a:ext uri="{FF2B5EF4-FFF2-40B4-BE49-F238E27FC236}">
                  <a16:creationId xmlns:a16="http://schemas.microsoft.com/office/drawing/2014/main" id="{AE906A8A-57A4-7140-9D34-9DA9C4E9F2DD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文本框 297">
              <a:extLst>
                <a:ext uri="{FF2B5EF4-FFF2-40B4-BE49-F238E27FC236}">
                  <a16:creationId xmlns:a16="http://schemas.microsoft.com/office/drawing/2014/main" id="{9AB137BB-19C3-37FE-8761-F931A7B0C708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文本框 298">
              <a:extLst>
                <a:ext uri="{FF2B5EF4-FFF2-40B4-BE49-F238E27FC236}">
                  <a16:creationId xmlns:a16="http://schemas.microsoft.com/office/drawing/2014/main" id="{C9293230-E89B-E192-3ABB-954F47A76AAA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文本框 299">
              <a:extLst>
                <a:ext uri="{FF2B5EF4-FFF2-40B4-BE49-F238E27FC236}">
                  <a16:creationId xmlns:a16="http://schemas.microsoft.com/office/drawing/2014/main" id="{BD11855B-0F5A-ADD2-E8EB-7C5540CE60EA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文本框 300">
              <a:extLst>
                <a:ext uri="{FF2B5EF4-FFF2-40B4-BE49-F238E27FC236}">
                  <a16:creationId xmlns:a16="http://schemas.microsoft.com/office/drawing/2014/main" id="{78E6E1E4-5EBE-B1DA-A3CC-D913C07152A4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文本框 301">
              <a:extLst>
                <a:ext uri="{FF2B5EF4-FFF2-40B4-BE49-F238E27FC236}">
                  <a16:creationId xmlns:a16="http://schemas.microsoft.com/office/drawing/2014/main" id="{83F81C72-FB26-660E-DA1E-7E039FB83274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文本框 302">
              <a:extLst>
                <a:ext uri="{FF2B5EF4-FFF2-40B4-BE49-F238E27FC236}">
                  <a16:creationId xmlns:a16="http://schemas.microsoft.com/office/drawing/2014/main" id="{3C618341-672A-02D5-07D0-3BD1BB9E640D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8953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61</Words>
  <Application>Microsoft Office PowerPoint</Application>
  <PresentationFormat>自定义</PresentationFormat>
  <Paragraphs>16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7</cp:revision>
  <dcterms:created xsi:type="dcterms:W3CDTF">2024-12-11T02:55:30Z</dcterms:created>
  <dcterms:modified xsi:type="dcterms:W3CDTF">2025-06-27T09:44:42Z</dcterms:modified>
</cp:coreProperties>
</file>